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20" y="15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567731C-1EBF-49F2-9056-A4A1C3CB4C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9270A18-5A6A-4C2C-B7D4-8C5153DEE7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E8F1191-800F-47FF-AF9F-3EEFC18FF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1786450-D661-47A6-A0E1-FACE82953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70D8D36-F067-4FC3-8DF0-88077655F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3408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E890F6-E040-4B9C-A250-83A1A1183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3D66054-AFFA-4C31-AD07-315B6FE6EF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51847E8-4A40-49C5-9A43-DC222BB02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42EF411-C845-4FA7-98E2-7891BA40E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96FCCD3-DA56-40C7-BE4C-9377C363F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8648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92004CC-7DF6-44D4-BFA6-061167DB4A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D2B5935-F9D6-46D6-8C67-F36FC80F21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D30C0F7-17BF-4D86-8DC2-FF6D30A6B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A102C89-79F8-436C-B57F-4B79CF5B7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684B419-23AD-4CAD-8965-F7D89E9F6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6503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DDDBBAB-1917-40A9-AD4E-69A747AD05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C847EAB-072C-47F1-A6B5-A3EBA175BB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B049DCF-1C03-44A9-B80E-C8B11223C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217E821-0F99-47DD-B350-CEBFD530E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F4ADB38-0C0D-43E3-A6B4-05DEED610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6372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3A4718-16FA-432E-B69E-8CE90A4C3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BDA4DAA-9F32-400F-A9B9-8AAE33CECA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5DEDCF-D321-49C5-8BAA-34F5E02B3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D64869-8C5C-4C4D-87BA-84FB661D4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AD9E706-4A11-46B2-8604-173670371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5934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979331-36C3-4EBD-9C4B-C409D6E52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18ED07A-6701-49D0-AFC9-9653916539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55F0D76-E46E-450F-B645-91C812DFF2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FF5CFD2-EF92-4D86-848A-7C4533AA2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DE14A08-3C4B-4C5E-ADA2-3976472BC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3FBC244-7222-4E41-91A1-C37567AAB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0187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05F5D1-E866-4AEC-BE1E-2A7B69FFD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4D99585-4834-46D5-96DE-52DE2D1856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A196CD9-C010-450C-A5FD-44FC98821D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E8AA6A5-0E3B-4404-A28A-2DA1502866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8D7A9FC-C7B0-4EF2-9D6A-7EB82D3B57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481BAAE-EF07-412E-9F51-903B4436F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BFC3C8A-748F-409B-A870-3AEF1787F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20CEA0F-88CA-4A96-B38A-551A4FCFB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057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01B319-D6A6-44A0-A781-1311D296B5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0CAB18A-C1F8-4C37-8830-96F91D239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3973309-DE1D-480A-AFAD-78D3D9189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7577129-157B-44B3-A8B8-3A60ECCD0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5895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554AD45-D551-4E51-A837-E6F1F1BF3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69D804-8F2E-4ACA-A3BE-E317D83D9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2605293-3746-49C9-83D1-CB7C506FA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7842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AEAD36-9D96-4276-846D-D0DB169F15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88A2DD8-9035-4239-ADE9-8337CBF3B7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C0B3332-BAA8-4828-BC80-77E6A22AD1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DB3A21C-7EA4-4D28-AFFF-95DC66F19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58C2741-0DB8-4015-8DBB-1886DFE85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F741157-FBA8-45E4-BACC-D11E7A607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0721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8D55C41-4950-4AC5-9274-661CCA998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B09D555-07A7-4B31-8BE5-08B41A7917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E1314DD-9B19-441A-A4BE-7572897188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3CEFEA5-A668-468A-A855-9E27307E3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18C405A-440A-4C6B-9770-9297236E5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721E04B-6DD4-4488-8979-D24BF83F9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5820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F4033B0-A8D9-4E02-A789-6482B46050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FD98091-4A13-4E1A-A35A-D7E4F88A56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C1970D3-A24B-4D0D-9E36-9EB9C167DF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1F5AF-B34F-4488-B6B5-48B9FA77A838}" type="datetimeFigureOut">
              <a:rPr lang="de-DE" smtClean="0"/>
              <a:t>30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226FD37-66C1-475E-9B46-8B668EFC05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C596A45-1A60-4C99-87AB-A57C7F635D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A2C90-0102-446F-9D53-E59AAFD14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3401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7DF64A43-7518-F7A0-19D6-CE1715EB312B}"/>
              </a:ext>
            </a:extLst>
          </p:cNvPr>
          <p:cNvSpPr txBox="1"/>
          <p:nvPr/>
        </p:nvSpPr>
        <p:spPr>
          <a:xfrm>
            <a:off x="848249" y="240959"/>
            <a:ext cx="10495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Anaerobic</a:t>
            </a:r>
            <a:r>
              <a:rPr lang="de-DE" dirty="0"/>
              <a:t> </a:t>
            </a:r>
            <a:r>
              <a:rPr lang="de-DE" dirty="0" err="1"/>
              <a:t>cultiv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consortium</a:t>
            </a:r>
            <a:r>
              <a:rPr lang="de-DE" dirty="0"/>
              <a:t> and </a:t>
            </a:r>
            <a:r>
              <a:rPr lang="de-DE" i="1" dirty="0"/>
              <a:t>Klebsiella </a:t>
            </a:r>
            <a:r>
              <a:rPr lang="de-DE" i="1" dirty="0" err="1"/>
              <a:t>pneumoniae</a:t>
            </a:r>
            <a:r>
              <a:rPr lang="de-DE" i="1" dirty="0"/>
              <a:t>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supernatants</a:t>
            </a:r>
            <a:r>
              <a:rPr lang="de-DE" dirty="0"/>
              <a:t> </a:t>
            </a:r>
            <a:r>
              <a:rPr lang="de-DE" dirty="0" err="1"/>
              <a:t>fed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i="1" dirty="0"/>
              <a:t>B. </a:t>
            </a:r>
            <a:r>
              <a:rPr lang="de-DE" i="1" dirty="0" err="1"/>
              <a:t>agri</a:t>
            </a:r>
            <a:r>
              <a:rPr lang="de-DE" i="1" dirty="0"/>
              <a:t> </a:t>
            </a:r>
            <a:r>
              <a:rPr lang="de-DE" dirty="0"/>
              <a:t>and</a:t>
            </a:r>
            <a:r>
              <a:rPr lang="de-DE" i="1" dirty="0"/>
              <a:t> B. </a:t>
            </a:r>
            <a:r>
              <a:rPr lang="de-DE" i="1" dirty="0" err="1"/>
              <a:t>fumarioli</a:t>
            </a:r>
            <a:endParaRPr lang="de-DE" i="1" dirty="0"/>
          </a:p>
        </p:txBody>
      </p:sp>
      <p:pic>
        <p:nvPicPr>
          <p:cNvPr id="14" name="Grafik 13" descr="Ein Bild, das Text, Screenshot, Diagramm, Reihe enthält.&#10;&#10;KI-generierte Inhalte können fehlerhaft sein.">
            <a:extLst>
              <a:ext uri="{FF2B5EF4-FFF2-40B4-BE49-F238E27FC236}">
                <a16:creationId xmlns:a16="http://schemas.microsoft.com/office/drawing/2014/main" id="{826FC4A0-207F-E9D7-6D1A-8511C87F69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04" y="806081"/>
            <a:ext cx="3773320" cy="2966759"/>
          </a:xfrm>
          <a:prstGeom prst="rect">
            <a:avLst/>
          </a:prstGeom>
        </p:spPr>
      </p:pic>
      <p:pic>
        <p:nvPicPr>
          <p:cNvPr id="16" name="Grafik 15" descr="Ein Bild, das Text, Screenshot, Diagramm, Reihe enthält.&#10;&#10;KI-generierte Inhalte können fehlerhaft sein.">
            <a:extLst>
              <a:ext uri="{FF2B5EF4-FFF2-40B4-BE49-F238E27FC236}">
                <a16:creationId xmlns:a16="http://schemas.microsoft.com/office/drawing/2014/main" id="{41B35152-67F2-F373-BA6E-E0732BED2E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214" y="806080"/>
            <a:ext cx="3773320" cy="2966760"/>
          </a:xfrm>
          <a:prstGeom prst="rect">
            <a:avLst/>
          </a:prstGeom>
        </p:spPr>
      </p:pic>
      <p:pic>
        <p:nvPicPr>
          <p:cNvPr id="22" name="Grafik 21" descr="Ein Bild, das Text, Diagramm, Reihe, Screenshot enthält.&#10;&#10;KI-generierte Inhalte können fehlerhaft sein.">
            <a:extLst>
              <a:ext uri="{FF2B5EF4-FFF2-40B4-BE49-F238E27FC236}">
                <a16:creationId xmlns:a16="http://schemas.microsoft.com/office/drawing/2014/main" id="{FA373872-D6BD-37E6-3298-679D6D2BB8C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8124" y="806081"/>
            <a:ext cx="3851958" cy="2966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4767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uchs, Thilo</dc:creator>
  <cp:lastModifiedBy>Fuchs, Thilo</cp:lastModifiedBy>
  <cp:revision>1</cp:revision>
  <dcterms:created xsi:type="dcterms:W3CDTF">2025-09-30T07:31:22Z</dcterms:created>
  <dcterms:modified xsi:type="dcterms:W3CDTF">2025-09-30T07:34:38Z</dcterms:modified>
</cp:coreProperties>
</file>